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6116638" cy="8093075"/>
  <p:notesSz cx="6858000" cy="9144000"/>
  <p:defaultTextStyle>
    <a:defPPr>
      <a:defRPr lang="en-US"/>
    </a:defPPr>
    <a:lvl1pPr marL="0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52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43" userDrawn="1">
          <p15:clr>
            <a:srgbClr val="A4A3A4"/>
          </p15:clr>
        </p15:guide>
        <p15:guide id="2" pos="2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  <a:srgbClr val="1B4DC0"/>
    <a:srgbClr val="D447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894" autoAdjust="0"/>
    <p:restoredTop sz="95220"/>
  </p:normalViewPr>
  <p:slideViewPr>
    <p:cSldViewPr snapToGrid="0" snapToObjects="1" showGuides="1">
      <p:cViewPr>
        <p:scale>
          <a:sx n="150" d="100"/>
          <a:sy n="150" d="100"/>
        </p:scale>
        <p:origin x="86" y="-1066"/>
      </p:cViewPr>
      <p:guideLst>
        <p:guide orient="horz" pos="2843"/>
        <p:guide pos="23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0B0F96-8563-CF4A-969C-34502BCA78C4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85800"/>
            <a:ext cx="25908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C942F3-F197-D94C-96E7-3A9D04780C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3852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1pPr>
    <a:lvl2pPr marL="387523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2pPr>
    <a:lvl3pPr marL="775045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3pPr>
    <a:lvl4pPr marL="1162568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4pPr>
    <a:lvl5pPr marL="1550091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5pPr>
    <a:lvl6pPr marL="1937614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6pPr>
    <a:lvl7pPr marL="2325136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7pPr>
    <a:lvl8pPr marL="2712659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8pPr>
    <a:lvl9pPr marL="3100182" algn="l" defTabSz="387523" rtl="0" eaLnBrk="1" latinLnBrk="0" hangingPunct="1">
      <a:defRPr sz="101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33600" y="685800"/>
            <a:ext cx="25908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C942F3-F197-D94C-96E7-3A9D04780C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310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748" y="2514100"/>
            <a:ext cx="5199142" cy="173476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7496" y="4586076"/>
            <a:ext cx="4281647" cy="20682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35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7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205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941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676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411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14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882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814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1775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325922" y="468349"/>
            <a:ext cx="1032183" cy="997396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9375" y="468349"/>
            <a:ext cx="2994604" cy="997396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285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243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173" y="5200551"/>
            <a:ext cx="5199142" cy="1607375"/>
          </a:xfrm>
        </p:spPr>
        <p:txBody>
          <a:bodyPr anchor="t"/>
          <a:lstStyle>
            <a:lvl1pPr algn="l">
              <a:defRPr sz="3268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173" y="3430191"/>
            <a:ext cx="5199142" cy="1770360"/>
          </a:xfrm>
        </p:spPr>
        <p:txBody>
          <a:bodyPr anchor="b"/>
          <a:lstStyle>
            <a:lvl1pPr marL="0" indent="0">
              <a:buNone/>
              <a:defRPr sz="1634">
                <a:solidFill>
                  <a:schemeClr val="tx1">
                    <a:tint val="75000"/>
                  </a:schemeClr>
                </a:solidFill>
              </a:defRPr>
            </a:lvl1pPr>
            <a:lvl2pPr marL="373532" indent="0">
              <a:buNone/>
              <a:defRPr sz="1471">
                <a:solidFill>
                  <a:schemeClr val="tx1">
                    <a:tint val="75000"/>
                  </a:schemeClr>
                </a:solidFill>
              </a:defRPr>
            </a:lvl2pPr>
            <a:lvl3pPr marL="747065" indent="0">
              <a:buNone/>
              <a:defRPr sz="1307">
                <a:solidFill>
                  <a:schemeClr val="tx1">
                    <a:tint val="75000"/>
                  </a:schemeClr>
                </a:solidFill>
              </a:defRPr>
            </a:lvl3pPr>
            <a:lvl4pPr marL="112059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4pPr>
            <a:lvl5pPr marL="1494130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5pPr>
            <a:lvl6pPr marL="1867662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6pPr>
            <a:lvl7pPr marL="2241194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7pPr>
            <a:lvl8pPr marL="2614727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8pPr>
            <a:lvl9pPr marL="2988259" indent="0">
              <a:buNone/>
              <a:defRPr sz="11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45531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9375" y="2727667"/>
            <a:ext cx="2013393" cy="7714649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344712" y="2727667"/>
            <a:ext cx="2013393" cy="7714649"/>
          </a:xfrm>
        </p:spPr>
        <p:txBody>
          <a:bodyPr/>
          <a:lstStyle>
            <a:lvl1pPr>
              <a:defRPr sz="2288"/>
            </a:lvl1pPr>
            <a:lvl2pPr>
              <a:defRPr sz="1961"/>
            </a:lvl2pPr>
            <a:lvl3pPr>
              <a:defRPr sz="1634"/>
            </a:lvl3pPr>
            <a:lvl4pPr>
              <a:defRPr sz="1471"/>
            </a:lvl4pPr>
            <a:lvl5pPr>
              <a:defRPr sz="1471"/>
            </a:lvl5pPr>
            <a:lvl6pPr>
              <a:defRPr sz="1471"/>
            </a:lvl6pPr>
            <a:lvl7pPr>
              <a:defRPr sz="1471"/>
            </a:lvl7pPr>
            <a:lvl8pPr>
              <a:defRPr sz="1471"/>
            </a:lvl8pPr>
            <a:lvl9pPr>
              <a:defRPr sz="1471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9771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324098"/>
            <a:ext cx="5504974" cy="1348846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3" y="1811575"/>
            <a:ext cx="2702577" cy="754979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5833" y="2566554"/>
            <a:ext cx="2702577" cy="4662886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7168" y="1811575"/>
            <a:ext cx="2703639" cy="754979"/>
          </a:xfrm>
        </p:spPr>
        <p:txBody>
          <a:bodyPr anchor="b"/>
          <a:lstStyle>
            <a:lvl1pPr marL="0" indent="0">
              <a:buNone/>
              <a:defRPr sz="1961" b="1"/>
            </a:lvl1pPr>
            <a:lvl2pPr marL="373532" indent="0">
              <a:buNone/>
              <a:defRPr sz="1634" b="1"/>
            </a:lvl2pPr>
            <a:lvl3pPr marL="747065" indent="0">
              <a:buNone/>
              <a:defRPr sz="1471" b="1"/>
            </a:lvl3pPr>
            <a:lvl4pPr marL="1120597" indent="0">
              <a:buNone/>
              <a:defRPr sz="1307" b="1"/>
            </a:lvl4pPr>
            <a:lvl5pPr marL="1494130" indent="0">
              <a:buNone/>
              <a:defRPr sz="1307" b="1"/>
            </a:lvl5pPr>
            <a:lvl6pPr marL="1867662" indent="0">
              <a:buNone/>
              <a:defRPr sz="1307" b="1"/>
            </a:lvl6pPr>
            <a:lvl7pPr marL="2241194" indent="0">
              <a:buNone/>
              <a:defRPr sz="1307" b="1"/>
            </a:lvl7pPr>
            <a:lvl8pPr marL="2614727" indent="0">
              <a:buNone/>
              <a:defRPr sz="1307" b="1"/>
            </a:lvl8pPr>
            <a:lvl9pPr marL="2988259" indent="0">
              <a:buNone/>
              <a:defRPr sz="130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7168" y="2566554"/>
            <a:ext cx="2703639" cy="4662886"/>
          </a:xfrm>
        </p:spPr>
        <p:txBody>
          <a:bodyPr/>
          <a:lstStyle>
            <a:lvl1pPr>
              <a:defRPr sz="1961"/>
            </a:lvl1pPr>
            <a:lvl2pPr>
              <a:defRPr sz="1634"/>
            </a:lvl2pPr>
            <a:lvl3pPr>
              <a:defRPr sz="1471"/>
            </a:lvl3pPr>
            <a:lvl4pPr>
              <a:defRPr sz="1307"/>
            </a:lvl4pPr>
            <a:lvl5pPr>
              <a:defRPr sz="1307"/>
            </a:lvl5pPr>
            <a:lvl6pPr>
              <a:defRPr sz="1307"/>
            </a:lvl6pPr>
            <a:lvl7pPr>
              <a:defRPr sz="1307"/>
            </a:lvl7pPr>
            <a:lvl8pPr>
              <a:defRPr sz="1307"/>
            </a:lvl8pPr>
            <a:lvl9pPr>
              <a:defRPr sz="130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5127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904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930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5832" y="322224"/>
            <a:ext cx="2012332" cy="1371327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1436" y="322225"/>
            <a:ext cx="3419371" cy="6907216"/>
          </a:xfrm>
        </p:spPr>
        <p:txBody>
          <a:bodyPr/>
          <a:lstStyle>
            <a:lvl1pPr>
              <a:defRPr sz="2614"/>
            </a:lvl1pPr>
            <a:lvl2pPr>
              <a:defRPr sz="2288"/>
            </a:lvl2pPr>
            <a:lvl3pPr>
              <a:defRPr sz="1961"/>
            </a:lvl3pPr>
            <a:lvl4pPr>
              <a:defRPr sz="1634"/>
            </a:lvl4pPr>
            <a:lvl5pPr>
              <a:defRPr sz="1634"/>
            </a:lvl5pPr>
            <a:lvl6pPr>
              <a:defRPr sz="1634"/>
            </a:lvl6pPr>
            <a:lvl7pPr>
              <a:defRPr sz="1634"/>
            </a:lvl7pPr>
            <a:lvl8pPr>
              <a:defRPr sz="1634"/>
            </a:lvl8pPr>
            <a:lvl9pPr>
              <a:defRPr sz="163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5832" y="1693551"/>
            <a:ext cx="2012332" cy="5535889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773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8904" y="5665152"/>
            <a:ext cx="3669983" cy="668804"/>
          </a:xfrm>
        </p:spPr>
        <p:txBody>
          <a:bodyPr anchor="b"/>
          <a:lstStyle>
            <a:lvl1pPr algn="l">
              <a:defRPr sz="1634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8904" y="723131"/>
            <a:ext cx="3669983" cy="4855845"/>
          </a:xfrm>
        </p:spPr>
        <p:txBody>
          <a:bodyPr/>
          <a:lstStyle>
            <a:lvl1pPr marL="0" indent="0">
              <a:buNone/>
              <a:defRPr sz="2614"/>
            </a:lvl1pPr>
            <a:lvl2pPr marL="373532" indent="0">
              <a:buNone/>
              <a:defRPr sz="2288"/>
            </a:lvl2pPr>
            <a:lvl3pPr marL="747065" indent="0">
              <a:buNone/>
              <a:defRPr sz="1961"/>
            </a:lvl3pPr>
            <a:lvl4pPr marL="1120597" indent="0">
              <a:buNone/>
              <a:defRPr sz="1634"/>
            </a:lvl4pPr>
            <a:lvl5pPr marL="1494130" indent="0">
              <a:buNone/>
              <a:defRPr sz="1634"/>
            </a:lvl5pPr>
            <a:lvl6pPr marL="1867662" indent="0">
              <a:buNone/>
              <a:defRPr sz="1634"/>
            </a:lvl6pPr>
            <a:lvl7pPr marL="2241194" indent="0">
              <a:buNone/>
              <a:defRPr sz="1634"/>
            </a:lvl7pPr>
            <a:lvl8pPr marL="2614727" indent="0">
              <a:buNone/>
              <a:defRPr sz="1634"/>
            </a:lvl8pPr>
            <a:lvl9pPr marL="2988259" indent="0">
              <a:buNone/>
              <a:defRPr sz="1634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8904" y="6333956"/>
            <a:ext cx="3669983" cy="949811"/>
          </a:xfrm>
        </p:spPr>
        <p:txBody>
          <a:bodyPr/>
          <a:lstStyle>
            <a:lvl1pPr marL="0" indent="0">
              <a:buNone/>
              <a:defRPr sz="1144"/>
            </a:lvl1pPr>
            <a:lvl2pPr marL="373532" indent="0">
              <a:buNone/>
              <a:defRPr sz="980"/>
            </a:lvl2pPr>
            <a:lvl3pPr marL="747065" indent="0">
              <a:buNone/>
              <a:defRPr sz="817"/>
            </a:lvl3pPr>
            <a:lvl4pPr marL="1120597" indent="0">
              <a:buNone/>
              <a:defRPr sz="735"/>
            </a:lvl4pPr>
            <a:lvl5pPr marL="1494130" indent="0">
              <a:buNone/>
              <a:defRPr sz="735"/>
            </a:lvl5pPr>
            <a:lvl6pPr marL="1867662" indent="0">
              <a:buNone/>
              <a:defRPr sz="735"/>
            </a:lvl6pPr>
            <a:lvl7pPr marL="2241194" indent="0">
              <a:buNone/>
              <a:defRPr sz="735"/>
            </a:lvl7pPr>
            <a:lvl8pPr marL="2614727" indent="0">
              <a:buNone/>
              <a:defRPr sz="735"/>
            </a:lvl8pPr>
            <a:lvl9pPr marL="2988259" indent="0">
              <a:buNone/>
              <a:defRPr sz="73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099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5832" y="324098"/>
            <a:ext cx="5504974" cy="13488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5832" y="1888385"/>
            <a:ext cx="5504974" cy="53410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5832" y="7501083"/>
            <a:ext cx="1427216" cy="430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9E6976-92C0-DB4E-A75F-8322C56F2F85}" type="datetimeFigureOut">
              <a:rPr lang="en-US" smtClean="0"/>
              <a:t>2019-12-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9852" y="7501083"/>
            <a:ext cx="1936935" cy="430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3590" y="7501083"/>
            <a:ext cx="1427216" cy="4308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B87BA5-30B1-2C48-A941-2FCF099E0C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98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3532" rtl="0" eaLnBrk="1" latinLnBrk="0" hangingPunct="1">
        <a:spcBef>
          <a:spcPct val="0"/>
        </a:spcBef>
        <a:buNone/>
        <a:defRPr sz="35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0149" indent="-280149" algn="l" defTabSz="373532" rtl="0" eaLnBrk="1" latinLnBrk="0" hangingPunct="1">
        <a:spcBef>
          <a:spcPct val="20000"/>
        </a:spcBef>
        <a:buFont typeface="Arial"/>
        <a:buChar char="•"/>
        <a:defRPr sz="2614" kern="1200">
          <a:solidFill>
            <a:schemeClr val="tx1"/>
          </a:solidFill>
          <a:latin typeface="+mn-lt"/>
          <a:ea typeface="+mn-ea"/>
          <a:cs typeface="+mn-cs"/>
        </a:defRPr>
      </a:lvl1pPr>
      <a:lvl2pPr marL="606990" indent="-233458" algn="l" defTabSz="373532" rtl="0" eaLnBrk="1" latinLnBrk="0" hangingPunct="1">
        <a:spcBef>
          <a:spcPct val="20000"/>
        </a:spcBef>
        <a:buFont typeface="Arial"/>
        <a:buChar char="–"/>
        <a:defRPr sz="2288" kern="1200">
          <a:solidFill>
            <a:schemeClr val="tx1"/>
          </a:solidFill>
          <a:latin typeface="+mn-lt"/>
          <a:ea typeface="+mn-ea"/>
          <a:cs typeface="+mn-cs"/>
        </a:defRPr>
      </a:lvl2pPr>
      <a:lvl3pPr marL="933831" indent="-186766" algn="l" defTabSz="373532" rtl="0" eaLnBrk="1" latinLnBrk="0" hangingPunct="1">
        <a:spcBef>
          <a:spcPct val="20000"/>
        </a:spcBef>
        <a:buFont typeface="Arial"/>
        <a:buChar char="•"/>
        <a:defRPr sz="1961" kern="1200">
          <a:solidFill>
            <a:schemeClr val="tx1"/>
          </a:solidFill>
          <a:latin typeface="+mn-lt"/>
          <a:ea typeface="+mn-ea"/>
          <a:cs typeface="+mn-cs"/>
        </a:defRPr>
      </a:lvl3pPr>
      <a:lvl4pPr marL="1307363" indent="-186766" algn="l" defTabSz="373532" rtl="0" eaLnBrk="1" latinLnBrk="0" hangingPunct="1">
        <a:spcBef>
          <a:spcPct val="20000"/>
        </a:spcBef>
        <a:buFont typeface="Arial"/>
        <a:buChar char="–"/>
        <a:defRPr sz="1634" kern="1200">
          <a:solidFill>
            <a:schemeClr val="tx1"/>
          </a:solidFill>
          <a:latin typeface="+mn-lt"/>
          <a:ea typeface="+mn-ea"/>
          <a:cs typeface="+mn-cs"/>
        </a:defRPr>
      </a:lvl4pPr>
      <a:lvl5pPr marL="1680896" indent="-186766" algn="l" defTabSz="373532" rtl="0" eaLnBrk="1" latinLnBrk="0" hangingPunct="1">
        <a:spcBef>
          <a:spcPct val="20000"/>
        </a:spcBef>
        <a:buFont typeface="Arial"/>
        <a:buChar char="»"/>
        <a:defRPr sz="1634" kern="1200">
          <a:solidFill>
            <a:schemeClr val="tx1"/>
          </a:solidFill>
          <a:latin typeface="+mn-lt"/>
          <a:ea typeface="+mn-ea"/>
          <a:cs typeface="+mn-cs"/>
        </a:defRPr>
      </a:lvl5pPr>
      <a:lvl6pPr marL="2054428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6pPr>
      <a:lvl7pPr marL="2427961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7pPr>
      <a:lvl8pPr marL="2801493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8pPr>
      <a:lvl9pPr marL="3175025" indent="-186766" algn="l" defTabSz="373532" rtl="0" eaLnBrk="1" latinLnBrk="0" hangingPunct="1">
        <a:spcBef>
          <a:spcPct val="20000"/>
        </a:spcBef>
        <a:buFont typeface="Arial"/>
        <a:buChar char="•"/>
        <a:defRPr sz="163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1pPr>
      <a:lvl2pPr marL="37353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2pPr>
      <a:lvl3pPr marL="747065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3pPr>
      <a:lvl4pPr marL="112059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4pPr>
      <a:lvl5pPr marL="1494130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5pPr>
      <a:lvl6pPr marL="1867662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6pPr>
      <a:lvl7pPr marL="2241194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7pPr>
      <a:lvl8pPr marL="2614727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8pPr>
      <a:lvl9pPr marL="2988259" algn="l" defTabSz="373532" rtl="0" eaLnBrk="1" latinLnBrk="0" hangingPunct="1">
        <a:defRPr sz="147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/>
          <p:cNvSpPr/>
          <p:nvPr/>
        </p:nvSpPr>
        <p:spPr>
          <a:xfrm>
            <a:off x="3264662" y="1174261"/>
            <a:ext cx="107575" cy="83670"/>
          </a:xfrm>
          <a:prstGeom prst="rect">
            <a:avLst/>
          </a:prstGeom>
          <a:noFill/>
          <a:ln w="19050">
            <a:solidFill>
              <a:schemeClr val="bg1">
                <a:lumMod val="65000"/>
              </a:schemeClr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6" name="Rectangle 15"/>
          <p:cNvSpPr/>
          <p:nvPr/>
        </p:nvSpPr>
        <p:spPr>
          <a:xfrm>
            <a:off x="3264662" y="938214"/>
            <a:ext cx="107575" cy="83670"/>
          </a:xfrm>
          <a:prstGeom prst="rect">
            <a:avLst/>
          </a:prstGeom>
          <a:solidFill>
            <a:schemeClr val="bg1">
              <a:lumMod val="65000"/>
            </a:schemeClr>
          </a:solidFill>
          <a:ln w="19050">
            <a:solidFill>
              <a:schemeClr val="bg1">
                <a:lumMod val="6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17" name="TextBox 16"/>
          <p:cNvSpPr txBox="1"/>
          <p:nvPr/>
        </p:nvSpPr>
        <p:spPr>
          <a:xfrm>
            <a:off x="3308881" y="875539"/>
            <a:ext cx="17556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    0 µg/mL AGI-134 + anti-Gal M86 + 2º Ab </a:t>
            </a:r>
          </a:p>
        </p:txBody>
      </p:sp>
      <p:sp>
        <p:nvSpPr>
          <p:cNvPr id="19" name="Rectangle 18"/>
          <p:cNvSpPr/>
          <p:nvPr/>
        </p:nvSpPr>
        <p:spPr>
          <a:xfrm>
            <a:off x="3264662" y="1056238"/>
            <a:ext cx="107575" cy="83670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00"/>
          </a:p>
        </p:txBody>
      </p:sp>
      <p:sp>
        <p:nvSpPr>
          <p:cNvPr id="20" name="TextBox 19"/>
          <p:cNvSpPr txBox="1"/>
          <p:nvPr/>
        </p:nvSpPr>
        <p:spPr>
          <a:xfrm>
            <a:off x="3353331" y="995929"/>
            <a:ext cx="175881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  50 µg/mL AGI-134 + anti-Gal M86 + 2º Ab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91431" y="1117512"/>
            <a:ext cx="17620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200 µg/mL AGI-134 + anti-Gal M86 + 2º Ab 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33326" y="304741"/>
            <a:ext cx="57606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/>
              </a:rPr>
              <a:t>A. Mouse M86 anti-Gal antibody binding to AGI-134-treated B16-F10 and JB/RH mouse melanoma cells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815118" y="520063"/>
            <a:ext cx="6655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B16-F10 cells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162169" y="539151"/>
            <a:ext cx="5934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JB/RH cells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233326" y="61081"/>
            <a:ext cx="1547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ea typeface="Arial" charset="0"/>
                <a:cs typeface="Arial" charset="0"/>
              </a:rPr>
              <a:t>Supplementary Figure S4.</a:t>
            </a:r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29311" y="2018167"/>
            <a:ext cx="1228404" cy="960992"/>
          </a:xfrm>
          <a:prstGeom prst="rect">
            <a:avLst/>
          </a:prstGeom>
        </p:spPr>
      </p:pic>
      <p:sp>
        <p:nvSpPr>
          <p:cNvPr id="78" name="TextBox 77"/>
          <p:cNvSpPr txBox="1"/>
          <p:nvPr/>
        </p:nvSpPr>
        <p:spPr>
          <a:xfrm>
            <a:off x="233326" y="1763892"/>
            <a:ext cx="43717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B. </a:t>
            </a:r>
            <a:r>
              <a:rPr lang="el-GR" sz="900" b="1" dirty="0">
                <a:cs typeface="Arial"/>
              </a:rPr>
              <a:t>α</a:t>
            </a:r>
            <a:r>
              <a:rPr lang="en-GB" sz="900" b="1" dirty="0">
                <a:cs typeface="Arial"/>
              </a:rPr>
              <a:t>1,3GT</a:t>
            </a:r>
            <a:r>
              <a:rPr lang="en-GB" sz="900" b="1" baseline="30000" dirty="0">
                <a:cs typeface="Arial"/>
              </a:rPr>
              <a:t>-/-</a:t>
            </a:r>
            <a:r>
              <a:rPr lang="en-US" sz="900" b="1" dirty="0">
                <a:cs typeface="Arial"/>
              </a:rPr>
              <a:t> mouse serum antibody binding to AGI-134-treated B16-F10 melanoma cells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1888377" y="2199916"/>
            <a:ext cx="3408924" cy="576691"/>
            <a:chOff x="3709392" y="2365356"/>
            <a:chExt cx="4172552" cy="705874"/>
          </a:xfrm>
        </p:grpSpPr>
        <p:sp>
          <p:nvSpPr>
            <p:cNvPr id="82" name="TextBox 81"/>
            <p:cNvSpPr txBox="1"/>
            <p:nvPr/>
          </p:nvSpPr>
          <p:spPr>
            <a:xfrm>
              <a:off x="3874965" y="2511345"/>
              <a:ext cx="4006979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500 µg/mL AGI-134 + serum non-immunized </a:t>
              </a:r>
              <a:r>
                <a:rPr lang="en-US" sz="700" dirty="0">
                  <a:ea typeface="Arial" charset="0"/>
                  <a:cs typeface="Arial" charset="0"/>
                </a:rPr>
                <a:t>α1,3GT</a:t>
              </a:r>
              <a:r>
                <a:rPr lang="en-US" sz="700" baseline="30000" dirty="0">
                  <a:ea typeface="Arial" charset="0"/>
                  <a:cs typeface="Arial" charset="0"/>
                </a:rPr>
                <a:t>-/-</a:t>
              </a:r>
              <a:r>
                <a:rPr lang="en-US" sz="700" dirty="0">
                  <a:ea typeface="Arial" charset="0"/>
                  <a:cs typeface="Arial" charset="0"/>
                </a:rPr>
                <a:t> </a:t>
              </a:r>
              <a:r>
                <a:rPr lang="en-US" sz="700" dirty="0">
                  <a:cs typeface="Arial"/>
                </a:rPr>
                <a:t>mice (low anti-Gal) + 2º Ab 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709392" y="2660164"/>
              <a:ext cx="3871594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      0 µg/mL AGI-134 + serum immunized </a:t>
              </a:r>
              <a:r>
                <a:rPr lang="en-US" sz="700" dirty="0">
                  <a:ea typeface="Arial" charset="0"/>
                  <a:cs typeface="Arial" charset="0"/>
                </a:rPr>
                <a:t>α1,3GT</a:t>
              </a:r>
              <a:r>
                <a:rPr lang="en-US" sz="700" baseline="30000" dirty="0">
                  <a:ea typeface="Arial" charset="0"/>
                  <a:cs typeface="Arial" charset="0"/>
                </a:rPr>
                <a:t>-/-</a:t>
              </a:r>
              <a:r>
                <a:rPr lang="en-US" sz="700" dirty="0">
                  <a:ea typeface="Arial" charset="0"/>
                  <a:cs typeface="Arial" charset="0"/>
                </a:rPr>
                <a:t> </a:t>
              </a:r>
              <a:r>
                <a:rPr lang="en-US" sz="700" dirty="0">
                  <a:cs typeface="Arial"/>
                </a:rPr>
                <a:t>mice (high anti-Gal) + 2º Ab 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773923" y="2365356"/>
              <a:ext cx="3999130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    0 µg/mL AGI-134 + serum non-immunized </a:t>
              </a:r>
              <a:r>
                <a:rPr lang="en-US" sz="700" dirty="0">
                  <a:ea typeface="Arial" charset="0"/>
                  <a:cs typeface="Arial" charset="0"/>
                </a:rPr>
                <a:t>α1,3GT</a:t>
              </a:r>
              <a:r>
                <a:rPr lang="en-US" sz="700" baseline="30000" dirty="0">
                  <a:ea typeface="Arial" charset="0"/>
                  <a:cs typeface="Arial" charset="0"/>
                </a:rPr>
                <a:t>-/-</a:t>
              </a:r>
              <a:r>
                <a:rPr lang="en-US" sz="700" dirty="0">
                  <a:ea typeface="Arial" charset="0"/>
                  <a:cs typeface="Arial" charset="0"/>
                </a:rPr>
                <a:t> </a:t>
              </a:r>
              <a:r>
                <a:rPr lang="en-US" sz="700" dirty="0">
                  <a:cs typeface="Arial"/>
                </a:rPr>
                <a:t>mice (low anti-Gal) + 2º Ab </a:t>
              </a: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790132" y="2448472"/>
              <a:ext cx="131673" cy="102413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3790132" y="2592934"/>
              <a:ext cx="131673" cy="10241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96" name="Rectangle 95"/>
            <p:cNvSpPr/>
            <p:nvPr/>
          </p:nvSpPr>
          <p:spPr>
            <a:xfrm>
              <a:off x="3790132" y="2737396"/>
              <a:ext cx="131673" cy="102413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 w="19050">
              <a:solidFill>
                <a:schemeClr val="tx1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103" name="Rectangle 102"/>
            <p:cNvSpPr/>
            <p:nvPr/>
          </p:nvSpPr>
          <p:spPr>
            <a:xfrm>
              <a:off x="3790132" y="2884050"/>
              <a:ext cx="131673" cy="102413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869333" y="2826361"/>
              <a:ext cx="3828428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500 µg/mL AGI-134 + serum immunized </a:t>
              </a:r>
              <a:r>
                <a:rPr lang="en-US" sz="700" dirty="0">
                  <a:ea typeface="Arial" charset="0"/>
                  <a:cs typeface="Arial" charset="0"/>
                </a:rPr>
                <a:t>α1,3GT</a:t>
              </a:r>
              <a:r>
                <a:rPr lang="en-US" sz="700" baseline="30000" dirty="0">
                  <a:ea typeface="Arial" charset="0"/>
                  <a:cs typeface="Arial" charset="0"/>
                </a:rPr>
                <a:t>-/-</a:t>
              </a:r>
              <a:r>
                <a:rPr lang="en-US" sz="700" dirty="0">
                  <a:cs typeface="Arial"/>
                </a:rPr>
                <a:t> mice (high anti-Gal) + 2º Ab </a:t>
              </a:r>
            </a:p>
          </p:txBody>
        </p:sp>
      </p:grpSp>
      <p:sp>
        <p:nvSpPr>
          <p:cNvPr id="105" name="TextBox 104"/>
          <p:cNvSpPr txBox="1"/>
          <p:nvPr/>
        </p:nvSpPr>
        <p:spPr>
          <a:xfrm>
            <a:off x="393936" y="2980193"/>
            <a:ext cx="15696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ea typeface="Arial" charset="0"/>
                <a:cs typeface="Arial" charset="0"/>
              </a:rPr>
              <a:t>FL-1 (= GT-KO serum IgG/IgM binding)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7011" y="689849"/>
            <a:ext cx="1193232" cy="79357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845205" y="697110"/>
            <a:ext cx="1163334" cy="793571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>
            <a:off x="233326" y="3213064"/>
            <a:ext cx="44678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cs typeface="Arial"/>
              </a:rPr>
              <a:t>C. AGI-134 drives complement deposition from </a:t>
            </a:r>
            <a:r>
              <a:rPr lang="el-GR" sz="900" b="1" dirty="0">
                <a:cs typeface="Arial"/>
              </a:rPr>
              <a:t>α</a:t>
            </a:r>
            <a:r>
              <a:rPr lang="en-GB" sz="900" b="1" dirty="0">
                <a:cs typeface="Arial"/>
              </a:rPr>
              <a:t>1,3GT</a:t>
            </a:r>
            <a:r>
              <a:rPr lang="en-GB" sz="900" b="1" baseline="30000" dirty="0">
                <a:cs typeface="Arial"/>
              </a:rPr>
              <a:t>-/-</a:t>
            </a:r>
            <a:r>
              <a:rPr lang="en-US" sz="900" b="1" dirty="0">
                <a:cs typeface="Arial"/>
              </a:rPr>
              <a:t> mouse serum onto B16-F10 cells</a:t>
            </a:r>
          </a:p>
        </p:txBody>
      </p:sp>
      <p:sp>
        <p:nvSpPr>
          <p:cNvPr id="108" name="Rectangle 107"/>
          <p:cNvSpPr/>
          <p:nvPr/>
        </p:nvSpPr>
        <p:spPr>
          <a:xfrm>
            <a:off x="1735936" y="3678705"/>
            <a:ext cx="21779" cy="5809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47"/>
          </a:p>
        </p:txBody>
      </p:sp>
      <p:pic>
        <p:nvPicPr>
          <p:cNvPr id="109" name="Picture 108"/>
          <p:cNvPicPr>
            <a:picLocks noChangeAspect="1"/>
          </p:cNvPicPr>
          <p:nvPr/>
        </p:nvPicPr>
        <p:blipFill rotWithShape="1"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9574" y="3555157"/>
            <a:ext cx="1492550" cy="945266"/>
          </a:xfrm>
          <a:prstGeom prst="rect">
            <a:avLst/>
          </a:prstGeom>
        </p:spPr>
      </p:pic>
      <p:pic>
        <p:nvPicPr>
          <p:cNvPr id="112" name="Picture 111"/>
          <p:cNvPicPr>
            <a:picLocks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06636" y="3558172"/>
            <a:ext cx="1489724" cy="942250"/>
          </a:xfrm>
          <a:prstGeom prst="rect">
            <a:avLst/>
          </a:prstGeom>
        </p:spPr>
      </p:pic>
      <p:sp>
        <p:nvSpPr>
          <p:cNvPr id="115" name="Rectangle 114"/>
          <p:cNvSpPr/>
          <p:nvPr/>
        </p:nvSpPr>
        <p:spPr>
          <a:xfrm>
            <a:off x="3394190" y="3736763"/>
            <a:ext cx="107575" cy="8367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116" name="TextBox 115"/>
          <p:cNvSpPr txBox="1"/>
          <p:nvPr/>
        </p:nvSpPr>
        <p:spPr>
          <a:xfrm>
            <a:off x="3393960" y="3684681"/>
            <a:ext cx="127150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    0 µg/mL AGI-134 + no serum  </a:t>
            </a:r>
          </a:p>
        </p:txBody>
      </p:sp>
      <p:sp>
        <p:nvSpPr>
          <p:cNvPr id="117" name="Rectangle 116"/>
          <p:cNvSpPr/>
          <p:nvPr/>
        </p:nvSpPr>
        <p:spPr>
          <a:xfrm>
            <a:off x="3394190" y="3854787"/>
            <a:ext cx="107575" cy="83670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118" name="TextBox 117"/>
          <p:cNvSpPr txBox="1"/>
          <p:nvPr/>
        </p:nvSpPr>
        <p:spPr>
          <a:xfrm>
            <a:off x="3393960" y="3809495"/>
            <a:ext cx="270298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    0 µg/mL AGI-134 + serum non-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mice </a:t>
            </a:r>
            <a:r>
              <a:rPr lang="en-US" sz="650" dirty="0">
                <a:cs typeface="Arial"/>
              </a:rPr>
              <a:t>(low anti-Gal) </a:t>
            </a:r>
          </a:p>
          <a:p>
            <a:endParaRPr lang="en-US" sz="650" dirty="0">
              <a:cs typeface="Arial"/>
            </a:endParaRPr>
          </a:p>
        </p:txBody>
      </p:sp>
      <p:sp>
        <p:nvSpPr>
          <p:cNvPr id="119" name="Rectangle 118"/>
          <p:cNvSpPr/>
          <p:nvPr/>
        </p:nvSpPr>
        <p:spPr>
          <a:xfrm>
            <a:off x="3394190" y="3972810"/>
            <a:ext cx="107575" cy="8367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120" name="TextBox 119"/>
          <p:cNvSpPr txBox="1"/>
          <p:nvPr/>
        </p:nvSpPr>
        <p:spPr>
          <a:xfrm>
            <a:off x="3393959" y="3926582"/>
            <a:ext cx="2569934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    0 µg/mL AGI-134 + serum 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</a:t>
            </a:r>
            <a:r>
              <a:rPr lang="en-US" sz="650" dirty="0">
                <a:cs typeface="Arial"/>
              </a:rPr>
              <a:t>mice (high anti-Gal) </a:t>
            </a:r>
          </a:p>
        </p:txBody>
      </p:sp>
      <p:sp>
        <p:nvSpPr>
          <p:cNvPr id="121" name="Rectangle 120"/>
          <p:cNvSpPr/>
          <p:nvPr/>
        </p:nvSpPr>
        <p:spPr>
          <a:xfrm>
            <a:off x="3394190" y="4090833"/>
            <a:ext cx="107575" cy="83670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123" name="TextBox 122"/>
          <p:cNvSpPr txBox="1"/>
          <p:nvPr/>
        </p:nvSpPr>
        <p:spPr>
          <a:xfrm>
            <a:off x="3463810" y="4051893"/>
            <a:ext cx="2709396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500 µg/mL AGI-134 + serum non-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mice </a:t>
            </a:r>
            <a:r>
              <a:rPr lang="en-US" sz="650" dirty="0">
                <a:cs typeface="Arial"/>
              </a:rPr>
              <a:t>(low anti-Gal) </a:t>
            </a:r>
          </a:p>
          <a:p>
            <a:endParaRPr lang="en-US" sz="650" dirty="0">
              <a:cs typeface="Arial"/>
            </a:endParaRPr>
          </a:p>
        </p:txBody>
      </p:sp>
      <p:sp>
        <p:nvSpPr>
          <p:cNvPr id="124" name="Rectangle 123"/>
          <p:cNvSpPr/>
          <p:nvPr/>
        </p:nvSpPr>
        <p:spPr>
          <a:xfrm>
            <a:off x="3394185" y="4210553"/>
            <a:ext cx="107575" cy="83670"/>
          </a:xfrm>
          <a:prstGeom prst="rect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125" name="TextBox 124"/>
          <p:cNvSpPr txBox="1"/>
          <p:nvPr/>
        </p:nvSpPr>
        <p:spPr>
          <a:xfrm>
            <a:off x="3463803" y="4177963"/>
            <a:ext cx="257634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500 µg/mL AGI-134 + serum 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</a:t>
            </a:r>
            <a:r>
              <a:rPr lang="en-US" sz="650" dirty="0">
                <a:cs typeface="Arial"/>
              </a:rPr>
              <a:t>mice (high anti-Gal) </a:t>
            </a:r>
          </a:p>
        </p:txBody>
      </p:sp>
      <p:sp>
        <p:nvSpPr>
          <p:cNvPr id="160" name="TextBox 159"/>
          <p:cNvSpPr txBox="1"/>
          <p:nvPr/>
        </p:nvSpPr>
        <p:spPr>
          <a:xfrm rot="16200000">
            <a:off x="142975" y="2331757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ea typeface="Arial" charset="0"/>
                <a:cs typeface="Arial" charset="0"/>
              </a:rPr>
              <a:t>Cell counts</a:t>
            </a:r>
          </a:p>
        </p:txBody>
      </p:sp>
      <p:grpSp>
        <p:nvGrpSpPr>
          <p:cNvPr id="48" name="Group 47"/>
          <p:cNvGrpSpPr/>
          <p:nvPr/>
        </p:nvGrpSpPr>
        <p:grpSpPr>
          <a:xfrm>
            <a:off x="337760" y="734824"/>
            <a:ext cx="1452882" cy="982769"/>
            <a:chOff x="175529" y="684715"/>
            <a:chExt cx="1778340" cy="1202919"/>
          </a:xfrm>
        </p:grpSpPr>
        <p:grpSp>
          <p:nvGrpSpPr>
            <p:cNvPr id="49" name="Group 48"/>
            <p:cNvGrpSpPr/>
            <p:nvPr/>
          </p:nvGrpSpPr>
          <p:grpSpPr>
            <a:xfrm>
              <a:off x="175529" y="684715"/>
              <a:ext cx="489859" cy="1069027"/>
              <a:chOff x="175529" y="636267"/>
              <a:chExt cx="489859" cy="1069027"/>
            </a:xfrm>
          </p:grpSpPr>
          <p:sp>
            <p:nvSpPr>
              <p:cNvPr id="51" name="TextBox 50"/>
              <p:cNvSpPr txBox="1"/>
              <p:nvPr/>
            </p:nvSpPr>
            <p:spPr>
              <a:xfrm rot="16200000">
                <a:off x="-48542" y="860338"/>
                <a:ext cx="693011" cy="2448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cs typeface="Arial"/>
                  </a:rPr>
                  <a:t>Cell</a:t>
                </a:r>
                <a:r>
                  <a:rPr lang="en-US" sz="654" dirty="0">
                    <a:cs typeface="Arial"/>
                  </a:rPr>
                  <a:t> counts</a:t>
                </a:r>
              </a:p>
            </p:txBody>
          </p:sp>
          <p:cxnSp>
            <p:nvCxnSpPr>
              <p:cNvPr id="52" name="Straight Arrow Connector 51"/>
              <p:cNvCxnSpPr/>
              <p:nvPr/>
            </p:nvCxnSpPr>
            <p:spPr>
              <a:xfrm flipV="1">
                <a:off x="299628" y="1339534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/>
              <p:nvPr/>
            </p:nvCxnSpPr>
            <p:spPr>
              <a:xfrm rot="5400000" flipV="1">
                <a:off x="482508" y="1522414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TextBox 49"/>
            <p:cNvSpPr txBox="1"/>
            <p:nvPr/>
          </p:nvSpPr>
          <p:spPr>
            <a:xfrm>
              <a:off x="650648" y="1642765"/>
              <a:ext cx="1303221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cs typeface="Arial"/>
                </a:rPr>
                <a:t>FL-4 (= Anti-Gal binding)</a:t>
              </a:r>
            </a:p>
          </p:txBody>
        </p:sp>
      </p:grpSp>
      <p:sp>
        <p:nvSpPr>
          <p:cNvPr id="54" name="TextBox 53"/>
          <p:cNvSpPr txBox="1"/>
          <p:nvPr/>
        </p:nvSpPr>
        <p:spPr>
          <a:xfrm>
            <a:off x="3573750" y="7079848"/>
            <a:ext cx="2622834" cy="2923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500 µg/mL FSL-A + serum non-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mice </a:t>
            </a:r>
            <a:r>
              <a:rPr lang="en-US" sz="650" dirty="0">
                <a:cs typeface="Arial"/>
              </a:rPr>
              <a:t>(low anti-Gal) </a:t>
            </a:r>
          </a:p>
          <a:p>
            <a:endParaRPr lang="en-US" sz="650" dirty="0"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582344" y="7194850"/>
            <a:ext cx="2489784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500 µg/mL FSL-A + serum 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</a:t>
            </a:r>
            <a:r>
              <a:rPr lang="en-US" sz="650" dirty="0">
                <a:cs typeface="Arial"/>
              </a:rPr>
              <a:t>mice (high anti-Gal) </a:t>
            </a:r>
          </a:p>
        </p:txBody>
      </p:sp>
      <p:sp>
        <p:nvSpPr>
          <p:cNvPr id="56" name="Rectangle 55"/>
          <p:cNvSpPr/>
          <p:nvPr/>
        </p:nvSpPr>
        <p:spPr>
          <a:xfrm>
            <a:off x="3135169" y="6930162"/>
            <a:ext cx="20550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 dirty="0"/>
              <a:t> </a:t>
            </a:r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58639" y="6599099"/>
            <a:ext cx="1616144" cy="1024436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68828" y="6600255"/>
            <a:ext cx="1531420" cy="1044476"/>
          </a:xfrm>
          <a:prstGeom prst="rect">
            <a:avLst/>
          </a:prstGeom>
        </p:spPr>
      </p:pic>
      <p:sp>
        <p:nvSpPr>
          <p:cNvPr id="64" name="Rectangle 63"/>
          <p:cNvSpPr/>
          <p:nvPr/>
        </p:nvSpPr>
        <p:spPr>
          <a:xfrm>
            <a:off x="3504131" y="6771493"/>
            <a:ext cx="107575" cy="83670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65" name="TextBox 64"/>
          <p:cNvSpPr txBox="1"/>
          <p:nvPr/>
        </p:nvSpPr>
        <p:spPr>
          <a:xfrm>
            <a:off x="3491201" y="6713061"/>
            <a:ext cx="1433406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    0 µg/mL FSL-A + no serum + 2º Ab </a:t>
            </a:r>
          </a:p>
        </p:txBody>
      </p:sp>
      <p:sp>
        <p:nvSpPr>
          <p:cNvPr id="66" name="Rectangle 65"/>
          <p:cNvSpPr/>
          <p:nvPr/>
        </p:nvSpPr>
        <p:spPr>
          <a:xfrm>
            <a:off x="3504131" y="6889517"/>
            <a:ext cx="107575" cy="83670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67" name="TextBox 66"/>
          <p:cNvSpPr txBox="1"/>
          <p:nvPr/>
        </p:nvSpPr>
        <p:spPr>
          <a:xfrm>
            <a:off x="3497550" y="6833203"/>
            <a:ext cx="261642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    0 µg/mL FSL-A + serum non-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mice </a:t>
            </a:r>
            <a:r>
              <a:rPr lang="en-US" sz="650" dirty="0">
                <a:cs typeface="Arial"/>
              </a:rPr>
              <a:t>(low anti-Gal) </a:t>
            </a:r>
          </a:p>
        </p:txBody>
      </p:sp>
      <p:sp>
        <p:nvSpPr>
          <p:cNvPr id="68" name="Rectangle 67"/>
          <p:cNvSpPr/>
          <p:nvPr/>
        </p:nvSpPr>
        <p:spPr>
          <a:xfrm>
            <a:off x="3504131" y="7007540"/>
            <a:ext cx="107575" cy="83670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69" name="TextBox 68"/>
          <p:cNvSpPr txBox="1"/>
          <p:nvPr/>
        </p:nvSpPr>
        <p:spPr>
          <a:xfrm>
            <a:off x="3497551" y="6953352"/>
            <a:ext cx="248337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>
                <a:cs typeface="Arial"/>
              </a:rPr>
              <a:t>    0 µg/mL FSL-A + serum immunized </a:t>
            </a:r>
            <a:r>
              <a:rPr lang="en-US" sz="650" dirty="0">
                <a:ea typeface="Arial" charset="0"/>
                <a:cs typeface="Arial" charset="0"/>
              </a:rPr>
              <a:t>α1,3GT</a:t>
            </a:r>
            <a:r>
              <a:rPr lang="en-US" sz="650" baseline="30000" dirty="0">
                <a:ea typeface="Arial" charset="0"/>
                <a:cs typeface="Arial" charset="0"/>
              </a:rPr>
              <a:t>-/-</a:t>
            </a:r>
            <a:r>
              <a:rPr lang="en-US" sz="650" dirty="0">
                <a:ea typeface="Arial" charset="0"/>
                <a:cs typeface="Arial" charset="0"/>
              </a:rPr>
              <a:t> </a:t>
            </a:r>
            <a:r>
              <a:rPr lang="en-US" sz="650" dirty="0">
                <a:cs typeface="Arial"/>
              </a:rPr>
              <a:t>mice (high anti-Gal) </a:t>
            </a:r>
          </a:p>
        </p:txBody>
      </p:sp>
      <p:sp>
        <p:nvSpPr>
          <p:cNvPr id="71" name="Rectangle 70"/>
          <p:cNvSpPr/>
          <p:nvPr/>
        </p:nvSpPr>
        <p:spPr>
          <a:xfrm>
            <a:off x="3504131" y="7125563"/>
            <a:ext cx="107575" cy="83670"/>
          </a:xfrm>
          <a:prstGeom prst="rect">
            <a:avLst/>
          </a:prstGeom>
          <a:solidFill>
            <a:schemeClr val="bg1">
              <a:lumMod val="75000"/>
            </a:schemeClr>
          </a:solidFill>
          <a:ln w="19050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sp>
        <p:nvSpPr>
          <p:cNvPr id="72" name="Rectangle 71"/>
          <p:cNvSpPr/>
          <p:nvPr/>
        </p:nvSpPr>
        <p:spPr>
          <a:xfrm>
            <a:off x="3504125" y="7245283"/>
            <a:ext cx="107575" cy="83670"/>
          </a:xfrm>
          <a:prstGeom prst="rect">
            <a:avLst/>
          </a:prstGeom>
          <a:solidFill>
            <a:schemeClr val="bg1">
              <a:lumMod val="50000"/>
            </a:schemeClr>
          </a:solidFill>
          <a:ln w="19050">
            <a:solidFill>
              <a:schemeClr val="tx1"/>
            </a:solidFill>
            <a:prstDash val="solid"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0"/>
          </a:p>
        </p:txBody>
      </p:sp>
      <p:grpSp>
        <p:nvGrpSpPr>
          <p:cNvPr id="73" name="Group 72"/>
          <p:cNvGrpSpPr/>
          <p:nvPr/>
        </p:nvGrpSpPr>
        <p:grpSpPr>
          <a:xfrm>
            <a:off x="2226285" y="5370662"/>
            <a:ext cx="1359904" cy="560916"/>
            <a:chOff x="80504" y="6499066"/>
            <a:chExt cx="1664531" cy="686566"/>
          </a:xfrm>
        </p:grpSpPr>
        <p:sp>
          <p:nvSpPr>
            <p:cNvPr id="74" name="Rectangle 73"/>
            <p:cNvSpPr/>
            <p:nvPr/>
          </p:nvSpPr>
          <p:spPr>
            <a:xfrm>
              <a:off x="150734" y="6579779"/>
              <a:ext cx="131673" cy="10241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0504" y="6499066"/>
              <a:ext cx="1481768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  0 </a:t>
              </a:r>
              <a:r>
                <a:rPr lang="en-US" sz="700" dirty="0">
                  <a:ea typeface="Symbol" charset="2"/>
                  <a:cs typeface="Symbol" charset="2"/>
                </a:rPr>
                <a:t>µ</a:t>
              </a:r>
              <a:r>
                <a:rPr lang="en-US" sz="700" dirty="0">
                  <a:cs typeface="Arial"/>
                </a:rPr>
                <a:t>g/mL FSL-A + anti-A,B</a:t>
              </a: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150734" y="6724241"/>
              <a:ext cx="131673" cy="102413"/>
            </a:xfrm>
            <a:prstGeom prst="rect">
              <a:avLst/>
            </a:prstGeom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127136" y="6646297"/>
              <a:ext cx="1485691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  10 </a:t>
              </a:r>
              <a:r>
                <a:rPr lang="en-US" sz="700" dirty="0">
                  <a:ea typeface="Symbol" charset="2"/>
                  <a:cs typeface="Symbol" charset="2"/>
                </a:rPr>
                <a:t>µ</a:t>
              </a:r>
              <a:r>
                <a:rPr lang="en-US" sz="700" dirty="0">
                  <a:cs typeface="Arial"/>
                </a:rPr>
                <a:t>g/mL FSL-A + anti-A,B</a:t>
              </a: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150734" y="6868703"/>
              <a:ext cx="131673" cy="102413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89316" y="6793529"/>
              <a:ext cx="1489616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  100 </a:t>
              </a:r>
              <a:r>
                <a:rPr lang="en-US" sz="700" dirty="0">
                  <a:ea typeface="Symbol" charset="2"/>
                  <a:cs typeface="Symbol" charset="2"/>
                </a:rPr>
                <a:t>µ</a:t>
              </a:r>
              <a:r>
                <a:rPr lang="en-US" sz="700" dirty="0">
                  <a:cs typeface="Arial"/>
                </a:rPr>
                <a:t>g/mL FSL-A + anti-A,B</a:t>
              </a: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150734" y="7013164"/>
              <a:ext cx="131673" cy="102413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 w="19050">
              <a:solidFill>
                <a:schemeClr val="tx1"/>
              </a:solidFill>
              <a:prstDash val="solid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51495" y="6940763"/>
              <a:ext cx="1493540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1000 </a:t>
              </a:r>
              <a:r>
                <a:rPr lang="en-US" sz="700" dirty="0">
                  <a:ea typeface="Symbol" charset="2"/>
                  <a:cs typeface="Symbol" charset="2"/>
                </a:rPr>
                <a:t>µ</a:t>
              </a:r>
              <a:r>
                <a:rPr lang="en-US" sz="700" dirty="0">
                  <a:cs typeface="Arial"/>
                </a:rPr>
                <a:t>g/mL FSL-A + anti-A,B</a:t>
              </a:r>
            </a:p>
          </p:txBody>
        </p:sp>
      </p:grpSp>
      <p:sp>
        <p:nvSpPr>
          <p:cNvPr id="91" name="TextBox 90"/>
          <p:cNvSpPr txBox="1"/>
          <p:nvPr/>
        </p:nvSpPr>
        <p:spPr>
          <a:xfrm>
            <a:off x="773852" y="6199291"/>
            <a:ext cx="1066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ea typeface="Arial" charset="0"/>
                <a:cs typeface="Arial" charset="0"/>
              </a:rPr>
              <a:t>FL-1 (= Anti-A,B binding)</a:t>
            </a:r>
          </a:p>
        </p:txBody>
      </p:sp>
      <p:pic>
        <p:nvPicPr>
          <p:cNvPr id="93" name="Picture 92"/>
          <p:cNvPicPr>
            <a:picLocks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64249" y="5196307"/>
            <a:ext cx="1591223" cy="1002985"/>
          </a:xfrm>
          <a:prstGeom prst="rect">
            <a:avLst/>
          </a:prstGeom>
        </p:spPr>
      </p:pic>
      <p:sp>
        <p:nvSpPr>
          <p:cNvPr id="94" name="TextBox 93"/>
          <p:cNvSpPr txBox="1"/>
          <p:nvPr/>
        </p:nvSpPr>
        <p:spPr>
          <a:xfrm rot="16200000">
            <a:off x="142770" y="5597771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ea typeface="Arial" charset="0"/>
                <a:cs typeface="Arial" charset="0"/>
              </a:rPr>
              <a:t>Cell counts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233326" y="4785285"/>
            <a:ext cx="57098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cs typeface="Arial"/>
              </a:rPr>
              <a:t>D. </a:t>
            </a:r>
            <a:r>
              <a:rPr lang="en-US" sz="900" b="1">
                <a:cs typeface="Arial"/>
              </a:rPr>
              <a:t>Blood </a:t>
            </a:r>
            <a:r>
              <a:rPr lang="en-US" sz="900" b="1" dirty="0">
                <a:cs typeface="Arial"/>
              </a:rPr>
              <a:t>group A glycolipid (FSL-A) incorporates into B16-F10 cells but does not drive complement deposition from </a:t>
            </a:r>
            <a:r>
              <a:rPr lang="el-GR" sz="900" b="1" dirty="0">
                <a:cs typeface="Arial"/>
              </a:rPr>
              <a:t>α</a:t>
            </a:r>
            <a:r>
              <a:rPr lang="en-GB" sz="900" b="1" dirty="0">
                <a:cs typeface="Arial"/>
              </a:rPr>
              <a:t>1,3GT</a:t>
            </a:r>
            <a:r>
              <a:rPr lang="en-GB" sz="900" b="1" baseline="30000" dirty="0">
                <a:cs typeface="Arial"/>
              </a:rPr>
              <a:t>-/-</a:t>
            </a:r>
            <a:r>
              <a:rPr lang="en-US" sz="900" b="1" dirty="0">
                <a:cs typeface="Arial"/>
              </a:rPr>
              <a:t> mouse serum 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885199" y="3415131"/>
            <a:ext cx="7633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C3b deposition 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2247026" y="3424939"/>
            <a:ext cx="8835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C5b-C9 deposition </a:t>
            </a:r>
          </a:p>
        </p:txBody>
      </p:sp>
      <p:grpSp>
        <p:nvGrpSpPr>
          <p:cNvPr id="102" name="Group 101"/>
          <p:cNvGrpSpPr/>
          <p:nvPr/>
        </p:nvGrpSpPr>
        <p:grpSpPr>
          <a:xfrm>
            <a:off x="329101" y="3703134"/>
            <a:ext cx="1765554" cy="992387"/>
            <a:chOff x="175526" y="672943"/>
            <a:chExt cx="2161055" cy="1214691"/>
          </a:xfrm>
        </p:grpSpPr>
        <p:grpSp>
          <p:nvGrpSpPr>
            <p:cNvPr id="106" name="Group 105"/>
            <p:cNvGrpSpPr/>
            <p:nvPr/>
          </p:nvGrpSpPr>
          <p:grpSpPr>
            <a:xfrm>
              <a:off x="175526" y="672943"/>
              <a:ext cx="489862" cy="1080799"/>
              <a:chOff x="175526" y="624495"/>
              <a:chExt cx="489862" cy="1080799"/>
            </a:xfrm>
          </p:grpSpPr>
          <p:sp>
            <p:nvSpPr>
              <p:cNvPr id="111" name="TextBox 110"/>
              <p:cNvSpPr txBox="1"/>
              <p:nvPr/>
            </p:nvSpPr>
            <p:spPr>
              <a:xfrm rot="16200000">
                <a:off x="-60317" y="860338"/>
                <a:ext cx="716556" cy="2448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cs typeface="Arial"/>
                  </a:rPr>
                  <a:t>Cell counts</a:t>
                </a:r>
              </a:p>
            </p:txBody>
          </p:sp>
          <p:cxnSp>
            <p:nvCxnSpPr>
              <p:cNvPr id="113" name="Straight Arrow Connector 112"/>
              <p:cNvCxnSpPr/>
              <p:nvPr/>
            </p:nvCxnSpPr>
            <p:spPr>
              <a:xfrm flipV="1">
                <a:off x="299628" y="1339534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Straight Arrow Connector 113"/>
              <p:cNvCxnSpPr/>
              <p:nvPr/>
            </p:nvCxnSpPr>
            <p:spPr>
              <a:xfrm rot="5400000" flipV="1">
                <a:off x="482508" y="1522414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7" name="TextBox 106"/>
            <p:cNvSpPr txBox="1"/>
            <p:nvPr/>
          </p:nvSpPr>
          <p:spPr>
            <a:xfrm>
              <a:off x="644865" y="1642765"/>
              <a:ext cx="1691716" cy="244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cs typeface="Arial"/>
                </a:rPr>
                <a:t>FL-1 (= Complement deposition )</a:t>
              </a:r>
            </a:p>
          </p:txBody>
        </p:sp>
      </p:grpSp>
      <p:sp>
        <p:nvSpPr>
          <p:cNvPr id="126" name="TextBox 125"/>
          <p:cNvSpPr txBox="1"/>
          <p:nvPr/>
        </p:nvSpPr>
        <p:spPr>
          <a:xfrm>
            <a:off x="920918" y="6455172"/>
            <a:ext cx="7633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C3b deposition 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2327126" y="6464980"/>
            <a:ext cx="8835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b="1" dirty="0">
                <a:ea typeface="Arial" charset="0"/>
                <a:cs typeface="Arial" charset="0"/>
              </a:rPr>
              <a:t>C5b-C9 deposition </a:t>
            </a:r>
          </a:p>
        </p:txBody>
      </p:sp>
      <p:sp>
        <p:nvSpPr>
          <p:cNvPr id="131" name="TextBox 130"/>
          <p:cNvSpPr txBox="1"/>
          <p:nvPr/>
        </p:nvSpPr>
        <p:spPr>
          <a:xfrm rot="16200000">
            <a:off x="136420" y="7032010"/>
            <a:ext cx="58541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cs typeface="Arial"/>
              </a:rPr>
              <a:t>Cell counts</a:t>
            </a:r>
          </a:p>
        </p:txBody>
      </p:sp>
      <p:cxnSp>
        <p:nvCxnSpPr>
          <p:cNvPr id="132" name="Straight Arrow Connector 131"/>
          <p:cNvCxnSpPr/>
          <p:nvPr/>
        </p:nvCxnSpPr>
        <p:spPr>
          <a:xfrm flipV="1">
            <a:off x="430491" y="7423507"/>
            <a:ext cx="0" cy="29882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/>
          <p:cNvCxnSpPr/>
          <p:nvPr/>
        </p:nvCxnSpPr>
        <p:spPr>
          <a:xfrm rot="5400000" flipV="1">
            <a:off x="579901" y="7572918"/>
            <a:ext cx="0" cy="29882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712545" y="7631662"/>
            <a:ext cx="13821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cs typeface="Arial"/>
              </a:rPr>
              <a:t>FL-1 (= Complement deposition )</a:t>
            </a:r>
          </a:p>
        </p:txBody>
      </p:sp>
    </p:spTree>
    <p:extLst>
      <p:ext uri="{BB962C8B-B14F-4D97-AF65-F5344CB8AC3E}">
        <p14:creationId xmlns:p14="http://schemas.microsoft.com/office/powerpoint/2010/main" val="2625117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71</TotalTime>
  <Words>427</Words>
  <Application>Microsoft Office PowerPoint</Application>
  <PresentationFormat>Custom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cha Kristian</dc:creator>
  <cp:lastModifiedBy>Arik Zur</cp:lastModifiedBy>
  <cp:revision>482</cp:revision>
  <cp:lastPrinted>2017-01-31T00:30:05Z</cp:lastPrinted>
  <dcterms:created xsi:type="dcterms:W3CDTF">2015-08-31T16:55:31Z</dcterms:created>
  <dcterms:modified xsi:type="dcterms:W3CDTF">2019-12-12T17:37:57Z</dcterms:modified>
</cp:coreProperties>
</file>